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720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94E7C2-AB4C-4AF3-98A5-2228B77FB704}" type="datetimeFigureOut">
              <a:rPr lang="en-GB" smtClean="0"/>
              <a:t>17/08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2BE8AB-C25E-4085-9F42-7687C2F309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92792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E045F2-C137-DF9C-9745-D3AA94B22F5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BE6E57E-B64C-CD87-4C10-35D8653073F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1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174319-38D4-8EC5-A07A-27AEF233E6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F226B-A4A9-4D06-AF24-33D5B5B7AC5B}" type="datetimeFigureOut">
              <a:rPr lang="en-GB" smtClean="0"/>
              <a:t>17/08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FB50AD-6D22-B5BD-E749-6A4580C851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EFC906-6619-0C8D-01BE-2E1ECCDA87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AAA12-A19A-4959-BF34-2EBE7505CF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82432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3C8694-0464-065C-189B-C165A14F54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B970B99-7761-9ED3-0518-02549973B4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0FE799-0407-9424-19DB-85C8F81EFB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F226B-A4A9-4D06-AF24-33D5B5B7AC5B}" type="datetimeFigureOut">
              <a:rPr lang="en-GB" smtClean="0"/>
              <a:t>17/08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8F8B75-D760-7F02-8B87-5E9EA2360F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A8B2C1-A727-DBFE-3E15-3D980E234A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AAA12-A19A-4959-BF34-2EBE7505CF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68027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C170607-B6FB-0730-F671-24846CD6847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2D21A65-19BF-EA84-EB1F-5879514E4B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EB6ED5-F951-B6FC-E6A3-0E22B63BC6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F226B-A4A9-4D06-AF24-33D5B5B7AC5B}" type="datetimeFigureOut">
              <a:rPr lang="en-GB" smtClean="0"/>
              <a:t>17/08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9E692D-8CC2-2581-66E5-3B936BB889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28B247-4F3A-075D-82C6-3899C9D36F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AAA12-A19A-4959-BF34-2EBE7505CF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06968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A4EEEA-6E94-F3F2-0967-1393A09440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FEFE81-09CA-0327-293C-7D27B8ED84B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74173E-F8B9-3E68-032E-3EE411C864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F226B-A4A9-4D06-AF24-33D5B5B7AC5B}" type="datetimeFigureOut">
              <a:rPr lang="en-GB" smtClean="0"/>
              <a:t>17/08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38D9B9-AC78-3CD2-F24C-206A4EA050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B3A341-99C7-5144-68F8-D9D43DA842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AAA12-A19A-4959-BF34-2EBE7505CF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4761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B3CDDF-8ED5-D35C-CCC4-D17871C58D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3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ECB21C-E19D-F35B-A134-0CD8E18756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3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1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48021B-46FA-DD7E-5845-5FC077B848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F226B-A4A9-4D06-AF24-33D5B5B7AC5B}" type="datetimeFigureOut">
              <a:rPr lang="en-GB" smtClean="0"/>
              <a:t>17/08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582D29-E7C9-5EF4-BA35-CC54E9E86E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062573-3E53-85C0-E074-EEE29C660D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AAA12-A19A-4959-BF34-2EBE7505CF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1491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F9165A-C7E4-65B0-9EEE-125B37C350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F0F80F-58FD-F914-4D15-DCE46F44FB9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D3A4CD-26EB-598B-3FA8-1EF50937E5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005ADC-552F-83B9-8685-726FF324F8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F226B-A4A9-4D06-AF24-33D5B5B7AC5B}" type="datetimeFigureOut">
              <a:rPr lang="en-GB" smtClean="0"/>
              <a:t>17/08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29521F-7446-7D1A-24F5-9CA21F140A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08D0CA-08B0-922B-B801-FBA6397F84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AAA12-A19A-4959-BF34-2EBE7505CF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56627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1D425F-8B95-7768-9EBE-7BAA6CE10A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28CFF8-A9CC-F6B1-028E-C00F7315F6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91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1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C98BA88-BA2F-8C05-7BD5-F97307A49A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91" y="2505076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65DE954-E5E6-4AE2-EB15-AA9A62C9A29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3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1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6BA61E7-42C7-A626-89EA-3896857FF0B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3" y="2505076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6C0977B-F7A5-9809-31D0-19C0844812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F226B-A4A9-4D06-AF24-33D5B5B7AC5B}" type="datetimeFigureOut">
              <a:rPr lang="en-GB" smtClean="0"/>
              <a:t>17/08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1FA18A1-3A16-574B-427C-89D4CD69CF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06E0CE1-E047-E306-6207-7CF59764EE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AAA12-A19A-4959-BF34-2EBE7505CF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87844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548CE6-27B9-02DA-DE4F-34AEE1865B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1F6EC4F-1672-6B9F-55EA-0FBF2F695F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F226B-A4A9-4D06-AF24-33D5B5B7AC5B}" type="datetimeFigureOut">
              <a:rPr lang="en-GB" smtClean="0"/>
              <a:t>17/08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0D78D5D-9E3D-5E43-FE5A-CCDB329F97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705796A-CE19-A789-7CA8-3847621936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AAA12-A19A-4959-BF34-2EBE7505CF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89007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B446554-3C77-F4DD-91BA-68CDDC17AD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F226B-A4A9-4D06-AF24-33D5B5B7AC5B}" type="datetimeFigureOut">
              <a:rPr lang="en-GB" smtClean="0"/>
              <a:t>17/08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44DC2A1-2DD5-11EC-FE6C-004EEE8323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5466433-2F9D-5824-02FD-63D7ADB8E9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AAA12-A19A-4959-BF34-2EBE7505CF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46306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090A71-F6DC-11F1-3C2C-4FB7AEC7A8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0FDDC4-64C3-2CE5-CFF3-7CF24114CA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90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56A7261-3DD8-FB0F-446A-D3A15B91C3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1"/>
            </a:lvl2pPr>
            <a:lvl3pPr marL="914411" indent="0">
              <a:buNone/>
              <a:defRPr sz="1200"/>
            </a:lvl3pPr>
            <a:lvl4pPr marL="1371617" indent="0">
              <a:buNone/>
              <a:defRPr sz="1001"/>
            </a:lvl4pPr>
            <a:lvl5pPr marL="1828823" indent="0">
              <a:buNone/>
              <a:defRPr sz="1001"/>
            </a:lvl5pPr>
            <a:lvl6pPr marL="2286029" indent="0">
              <a:buNone/>
              <a:defRPr sz="1001"/>
            </a:lvl6pPr>
            <a:lvl7pPr marL="2743234" indent="0">
              <a:buNone/>
              <a:defRPr sz="1001"/>
            </a:lvl7pPr>
            <a:lvl8pPr marL="3200440" indent="0">
              <a:buNone/>
              <a:defRPr sz="1001"/>
            </a:lvl8pPr>
            <a:lvl9pPr marL="3657646" indent="0">
              <a:buNone/>
              <a:defRPr sz="100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93C55A9-EAD6-33B5-B4C1-9F7E1971E6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F226B-A4A9-4D06-AF24-33D5B5B7AC5B}" type="datetimeFigureOut">
              <a:rPr lang="en-GB" smtClean="0"/>
              <a:t>17/08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6640AB-FDD2-6F77-BAC1-64444946D4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6F4C8B0-7B08-F0F3-1D7C-E683881485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AAA12-A19A-4959-BF34-2EBE7505CF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07941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6A423C-8A9F-C157-B441-1DF0874B39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6DB7D94-906B-CFE4-0616-712EF69E7E6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90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1CB664B-5962-3622-EF2E-F26BE46B60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1"/>
            </a:lvl2pPr>
            <a:lvl3pPr marL="914411" indent="0">
              <a:buNone/>
              <a:defRPr sz="1200"/>
            </a:lvl3pPr>
            <a:lvl4pPr marL="1371617" indent="0">
              <a:buNone/>
              <a:defRPr sz="1001"/>
            </a:lvl4pPr>
            <a:lvl5pPr marL="1828823" indent="0">
              <a:buNone/>
              <a:defRPr sz="1001"/>
            </a:lvl5pPr>
            <a:lvl6pPr marL="2286029" indent="0">
              <a:buNone/>
              <a:defRPr sz="1001"/>
            </a:lvl6pPr>
            <a:lvl7pPr marL="2743234" indent="0">
              <a:buNone/>
              <a:defRPr sz="1001"/>
            </a:lvl7pPr>
            <a:lvl8pPr marL="3200440" indent="0">
              <a:buNone/>
              <a:defRPr sz="1001"/>
            </a:lvl8pPr>
            <a:lvl9pPr marL="3657646" indent="0">
              <a:buNone/>
              <a:defRPr sz="100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532297-ED65-A04D-9093-2D0CB552A4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F226B-A4A9-4D06-AF24-33D5B5B7AC5B}" type="datetimeFigureOut">
              <a:rPr lang="en-GB" smtClean="0"/>
              <a:t>17/08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2D5FC45-AB3E-5C38-54CA-254B432227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C269FF-6ED1-C295-F8E7-E9155227E2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AAA12-A19A-4959-BF34-2EBE7505CF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21647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EB1AFF1-E6BB-8261-784A-E3BCA5BD17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4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9F22E9-2AE2-BD7A-B730-9FF209BE62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4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98E24C-77BE-FFDA-2EB9-FA0E21E792E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5F226B-A4A9-4D06-AF24-33D5B5B7AC5B}" type="datetimeFigureOut">
              <a:rPr lang="en-GB" smtClean="0"/>
              <a:t>17/08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02F93F-8EA5-E3A5-2993-9F27CAAC61E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4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4D1F8C-D02E-9607-351D-727C6B2714B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8AAA12-A19A-4959-BF34-2EBE7505CF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2418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4" indent="-228604" algn="l" defTabSz="914411" rtl="0" eaLnBrk="1" latinLnBrk="0" hangingPunct="1">
        <a:lnSpc>
          <a:spcPct val="90000"/>
        </a:lnSpc>
        <a:spcBef>
          <a:spcPts val="1001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9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5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1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7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8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4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9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B72C7724-D963-65A9-E8F4-DC95E5A9892F}"/>
              </a:ext>
            </a:extLst>
          </p:cNvPr>
          <p:cNvSpPr txBox="1"/>
          <p:nvPr/>
        </p:nvSpPr>
        <p:spPr>
          <a:xfrm>
            <a:off x="414867" y="5850467"/>
            <a:ext cx="1157393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Figure 1. </a:t>
            </a:r>
            <a:r>
              <a:rPr lang="en-US" b="1" dirty="0"/>
              <a:t>Cell viability of H460 lung cancer cells following treatment with combination therapies.</a:t>
            </a:r>
            <a:r>
              <a:rPr lang="en-US" dirty="0"/>
              <a:t> Cell viability was measured following combination treatments at 24 and 48 hours. p-values: * &lt;0.05, ** &lt; 0.01, *** &lt; 0.0001, **** &lt; 0.0001 compared to control. The experiment was carried out in triplicates.</a:t>
            </a:r>
            <a:endParaRPr lang="en-GB" dirty="0"/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0437CA53-B696-A12A-7781-F9D6F1B1C67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68213973"/>
              </p:ext>
            </p:extLst>
          </p:nvPr>
        </p:nvGraphicFramePr>
        <p:xfrm>
          <a:off x="2630099" y="477136"/>
          <a:ext cx="6280635" cy="52897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4226355" imgH="3558728" progId="Prism8.Document">
                  <p:embed/>
                </p:oleObj>
              </mc:Choice>
              <mc:Fallback>
                <p:oleObj name="Prism 8" r:id="rId2" imgW="4226355" imgH="355872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630099" y="477136"/>
                        <a:ext cx="6280635" cy="528970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6708472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B11C4E4-C65C-A140-6D5F-6D9081CA6CC9}"/>
              </a:ext>
            </a:extLst>
          </p:cNvPr>
          <p:cNvSpPr txBox="1"/>
          <p:nvPr/>
        </p:nvSpPr>
        <p:spPr>
          <a:xfrm>
            <a:off x="414867" y="5545667"/>
            <a:ext cx="1157393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Table 1.</a:t>
            </a:r>
            <a:r>
              <a:rPr lang="en-US" b="1" dirty="0"/>
              <a:t> Combination Index (CI) in H460 of Cisplatin with BKM120 after 24 and 48 hours and 5-FU with BKM120 for 24h. </a:t>
            </a:r>
            <a:r>
              <a:rPr lang="en-GB" b="1" dirty="0"/>
              <a:t> 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E00121B1-92AC-31EF-C2F0-D54549E1718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56029735"/>
              </p:ext>
            </p:extLst>
          </p:nvPr>
        </p:nvGraphicFramePr>
        <p:xfrm>
          <a:off x="2132756" y="638201"/>
          <a:ext cx="7087444" cy="4709523"/>
        </p:xfrm>
        <a:graphic>
          <a:graphicData uri="http://schemas.openxmlformats.org/drawingml/2006/table">
            <a:tbl>
              <a:tblPr firstRow="1" firstCol="1" bandRow="1">
                <a:tableStyleId>{C083E6E3-FA7D-4D7B-A595-EF9225AFEA82}</a:tableStyleId>
              </a:tblPr>
              <a:tblGrid>
                <a:gridCol w="2669727">
                  <a:extLst>
                    <a:ext uri="{9D8B030D-6E8A-4147-A177-3AD203B41FA5}">
                      <a16:colId xmlns:a16="http://schemas.microsoft.com/office/drawing/2014/main" val="2013221531"/>
                    </a:ext>
                  </a:extLst>
                </a:gridCol>
                <a:gridCol w="2092033">
                  <a:extLst>
                    <a:ext uri="{9D8B030D-6E8A-4147-A177-3AD203B41FA5}">
                      <a16:colId xmlns:a16="http://schemas.microsoft.com/office/drawing/2014/main" val="1261672723"/>
                    </a:ext>
                  </a:extLst>
                </a:gridCol>
                <a:gridCol w="1162842">
                  <a:extLst>
                    <a:ext uri="{9D8B030D-6E8A-4147-A177-3AD203B41FA5}">
                      <a16:colId xmlns:a16="http://schemas.microsoft.com/office/drawing/2014/main" val="122754965"/>
                    </a:ext>
                  </a:extLst>
                </a:gridCol>
                <a:gridCol w="1162842">
                  <a:extLst>
                    <a:ext uri="{9D8B030D-6E8A-4147-A177-3AD203B41FA5}">
                      <a16:colId xmlns:a16="http://schemas.microsoft.com/office/drawing/2014/main" val="1995503661"/>
                    </a:ext>
                  </a:extLst>
                </a:gridCol>
              </a:tblGrid>
              <a:tr h="240333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 dirty="0">
                          <a:effectLst/>
                        </a:rPr>
                        <a:t>Dose Cisplatin 24h</a:t>
                      </a:r>
                      <a:endParaRPr lang="en-GB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 dirty="0">
                          <a:effectLst/>
                        </a:rPr>
                        <a:t>Dose BKM120 24h</a:t>
                      </a:r>
                      <a:endParaRPr lang="en-GB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Effect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CI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4199050455"/>
                  </a:ext>
                </a:extLst>
              </a:tr>
              <a:tr h="355028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1.0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0.1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0.99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 dirty="0">
                          <a:effectLst/>
                        </a:rPr>
                        <a:t>278.7</a:t>
                      </a:r>
                      <a:endParaRPr lang="en-GB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403595402"/>
                  </a:ext>
                </a:extLst>
              </a:tr>
              <a:tr h="316474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1.0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0.5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0.99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 dirty="0">
                          <a:effectLst/>
                        </a:rPr>
                        <a:t>1393.4</a:t>
                      </a:r>
                      <a:endParaRPr lang="en-GB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4076794222"/>
                  </a:ext>
                </a:extLst>
              </a:tr>
              <a:tr h="316474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1.0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1.0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0.99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 dirty="0">
                          <a:effectLst/>
                        </a:rPr>
                        <a:t>2786.8</a:t>
                      </a:r>
                      <a:endParaRPr lang="en-GB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3121571999"/>
                  </a:ext>
                </a:extLst>
              </a:tr>
              <a:tr h="316474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10.0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0.1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0.81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 dirty="0">
                          <a:effectLst/>
                        </a:rPr>
                        <a:t>4.6</a:t>
                      </a:r>
                      <a:endParaRPr lang="en-GB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4210207965"/>
                  </a:ext>
                </a:extLst>
              </a:tr>
              <a:tr h="316474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10.0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0.5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0.72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 dirty="0">
                          <a:effectLst/>
                        </a:rPr>
                        <a:t>7.9</a:t>
                      </a:r>
                      <a:endParaRPr lang="en-GB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3731551367"/>
                  </a:ext>
                </a:extLst>
              </a:tr>
              <a:tr h="316474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10.0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1.0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0.55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 dirty="0">
                          <a:effectLst/>
                        </a:rPr>
                        <a:t>14.8</a:t>
                      </a:r>
                      <a:endParaRPr lang="en-GB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3139486523"/>
                  </a:ext>
                </a:extLst>
              </a:tr>
              <a:tr h="316474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 dirty="0">
                          <a:effectLst/>
                        </a:rPr>
                        <a:t>Dose Cisplatin 48h</a:t>
                      </a:r>
                      <a:endParaRPr lang="en-GB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 b="1" dirty="0">
                          <a:effectLst/>
                        </a:rPr>
                        <a:t>Dose BKM120 48h</a:t>
                      </a:r>
                      <a:endParaRPr lang="en-GB" sz="1400" b="1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Effect 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CI 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287382067"/>
                  </a:ext>
                </a:extLst>
              </a:tr>
              <a:tr h="316474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1.0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0.1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0.91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 dirty="0">
                          <a:effectLst/>
                        </a:rPr>
                        <a:t>5.3</a:t>
                      </a:r>
                      <a:endParaRPr lang="en-GB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884225727"/>
                  </a:ext>
                </a:extLst>
              </a:tr>
              <a:tr h="316474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1.0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0.5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0.62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 dirty="0">
                          <a:effectLst/>
                        </a:rPr>
                        <a:t>1.0</a:t>
                      </a:r>
                      <a:endParaRPr lang="en-GB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632889532"/>
                  </a:ext>
                </a:extLst>
              </a:tr>
              <a:tr h="316474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1.0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1.0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0.6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 dirty="0">
                          <a:effectLst/>
                        </a:rPr>
                        <a:t>1.5</a:t>
                      </a:r>
                      <a:endParaRPr lang="en-GB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52113792"/>
                  </a:ext>
                </a:extLst>
              </a:tr>
              <a:tr h="316474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 dirty="0">
                          <a:effectLst/>
                        </a:rPr>
                        <a:t>Dose 5-FU 24h</a:t>
                      </a:r>
                      <a:endParaRPr lang="en-GB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 b="1" dirty="0">
                          <a:effectLst/>
                        </a:rPr>
                        <a:t>Dose BKM120 24h</a:t>
                      </a:r>
                      <a:endParaRPr lang="en-GB" sz="1400" b="1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Effect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 dirty="0">
                          <a:effectLst/>
                        </a:rPr>
                        <a:t>CI</a:t>
                      </a:r>
                      <a:endParaRPr lang="en-GB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3541150682"/>
                  </a:ext>
                </a:extLst>
              </a:tr>
              <a:tr h="316474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10.0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0.1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0.85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 dirty="0">
                          <a:effectLst/>
                        </a:rPr>
                        <a:t>2.9</a:t>
                      </a:r>
                      <a:endParaRPr lang="en-GB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111437465"/>
                  </a:ext>
                </a:extLst>
              </a:tr>
              <a:tr h="316474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10.0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0.5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0.71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 dirty="0">
                          <a:effectLst/>
                        </a:rPr>
                        <a:t>1.7</a:t>
                      </a:r>
                      <a:endParaRPr lang="en-GB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3136958988"/>
                  </a:ext>
                </a:extLst>
              </a:tr>
              <a:tr h="316474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10.0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1.0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>
                          <a:effectLst/>
                        </a:rPr>
                        <a:t>0.61</a:t>
                      </a:r>
                      <a:endParaRPr lang="en-GB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buNone/>
                      </a:pPr>
                      <a:r>
                        <a:rPr lang="en-US" sz="1400" dirty="0">
                          <a:effectLst/>
                        </a:rPr>
                        <a:t>1.3</a:t>
                      </a:r>
                      <a:endParaRPr lang="en-GB" sz="14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41834054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524524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44A1EFC-7726-63B0-EBA9-E495B690BFAE}"/>
              </a:ext>
            </a:extLst>
          </p:cNvPr>
          <p:cNvSpPr txBox="1"/>
          <p:nvPr/>
        </p:nvSpPr>
        <p:spPr>
          <a:xfrm>
            <a:off x="414867" y="5850467"/>
            <a:ext cx="1177713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Figure 2. Combination of 5-FU and BKM120 caused a decrease in Bcl-2 mRNA levels.</a:t>
            </a:r>
          </a:p>
          <a:p>
            <a:r>
              <a:rPr lang="en-US" dirty="0"/>
              <a:t>p-values: ** &lt; 0.01, **** &lt; 0.0001 compared to control. The experiment was carried out in triplicates.</a:t>
            </a:r>
            <a:endParaRPr lang="en-GB" dirty="0"/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A1AB3F65-B660-2A8A-F449-240A9F12ED5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93347448"/>
              </p:ext>
            </p:extLst>
          </p:nvPr>
        </p:nvGraphicFramePr>
        <p:xfrm>
          <a:off x="3996709" y="1013417"/>
          <a:ext cx="4363519" cy="43483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189195" imgH="3178821" progId="Prism8.Document">
                  <p:embed/>
                </p:oleObj>
              </mc:Choice>
              <mc:Fallback>
                <p:oleObj name="Prism 8" r:id="rId2" imgW="3189195" imgH="317882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996709" y="1013417"/>
                        <a:ext cx="4363519" cy="43483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5863874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82</TotalTime>
  <Words>196</Words>
  <Application>Microsoft Office PowerPoint</Application>
  <PresentationFormat>Widescreen</PresentationFormat>
  <Paragraphs>64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Palatino Linotype</vt:lpstr>
      <vt:lpstr>Office Theme</vt:lpstr>
      <vt:lpstr>Prism 8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ristiana Neophytou</dc:creator>
  <cp:lastModifiedBy>Christiana Neophytou</cp:lastModifiedBy>
  <cp:revision>12</cp:revision>
  <dcterms:created xsi:type="dcterms:W3CDTF">2025-07-25T06:28:30Z</dcterms:created>
  <dcterms:modified xsi:type="dcterms:W3CDTF">2025-08-17T09:55:44Z</dcterms:modified>
</cp:coreProperties>
</file>